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11"/>
    <p:restoredTop sz="94694"/>
  </p:normalViewPr>
  <p:slideViewPr>
    <p:cSldViewPr snapToGrid="0" snapToObjects="1">
      <p:cViewPr varScale="1">
        <p:scale>
          <a:sx n="77" d="100"/>
          <a:sy n="77" d="100"/>
        </p:scale>
        <p:origin x="396" y="78"/>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72DC79-7D74-1D48-B69B-2DB1D24CAB49}"/>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82B6B12B-366D-AF49-AF4F-EA8BF573A1C7}"/>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1DF5A11F-D1BE-B840-A5D7-4B7B99A3DA3A}"/>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5" name="Footer Placeholder 4">
            <a:extLst>
              <a:ext uri="{FF2B5EF4-FFF2-40B4-BE49-F238E27FC236}">
                <a16:creationId xmlns:a16="http://schemas.microsoft.com/office/drawing/2014/main" id="{205F9383-0375-5B40-B329-5FBD2F4F194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BD713C7-BB0E-4245-8A34-D0D19A4636D9}"/>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344685347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6ABBFA-B32E-5145-9DEF-603CB991420D}"/>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F32F7AB-0772-5B49-88D5-874052AB892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4E34A49-8761-0F4C-9F7F-033FAE5D2CB2}"/>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5" name="Footer Placeholder 4">
            <a:extLst>
              <a:ext uri="{FF2B5EF4-FFF2-40B4-BE49-F238E27FC236}">
                <a16:creationId xmlns:a16="http://schemas.microsoft.com/office/drawing/2014/main" id="{CE22F3D9-86D2-AB42-BDAC-14322572F7A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62DB416-7792-4142-9879-3300FA20B0E8}"/>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164816541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EF8B2A74-0202-A54F-AD37-DBEC7C107FF2}"/>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0DE96520-BADD-B049-9572-56F9595B888B}"/>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C3562B3-E109-AA4E-8C8C-09BFE0B7E005}"/>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5" name="Footer Placeholder 4">
            <a:extLst>
              <a:ext uri="{FF2B5EF4-FFF2-40B4-BE49-F238E27FC236}">
                <a16:creationId xmlns:a16="http://schemas.microsoft.com/office/drawing/2014/main" id="{5C08DB87-550A-4D45-8770-66402A971A1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E9A24F9-8C92-5F4C-8945-5167804A28E6}"/>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420637899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01F7AB2-685E-524A-A779-568909E46F1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3FF9704F-3AC9-2440-80AF-08B4206B4F3F}"/>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8B995BF-CF5A-6E47-98EA-2FC5792A26F8}"/>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5" name="Footer Placeholder 4">
            <a:extLst>
              <a:ext uri="{FF2B5EF4-FFF2-40B4-BE49-F238E27FC236}">
                <a16:creationId xmlns:a16="http://schemas.microsoft.com/office/drawing/2014/main" id="{7A7F1AA7-882F-AD40-BCA8-EFBF75F7DF2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5E78056B-198F-B249-B3AC-48F4157AF7D4}"/>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26681532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4646AEB-EEDC-6A49-9E3D-8AF8A105720F}"/>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CDBD01E0-346B-5B46-A2B4-4CF3CC62371A}"/>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0AE61FAC-48B4-1644-891F-1B7FCE9B7554}"/>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5" name="Footer Placeholder 4">
            <a:extLst>
              <a:ext uri="{FF2B5EF4-FFF2-40B4-BE49-F238E27FC236}">
                <a16:creationId xmlns:a16="http://schemas.microsoft.com/office/drawing/2014/main" id="{CDEBFC86-7F34-0946-A57F-75924A840E1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9E0D298-F0BB-7249-848C-B21A91CD8E29}"/>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41784068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A801302-C72D-6043-8691-6163DF960316}"/>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67FCD9FE-2FE5-654A-BC0C-197626EDEBF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5756255-C5C9-7F4E-88AC-9383D1804BF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89754577-7A17-884F-A50C-18FBF84F19A4}"/>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6" name="Footer Placeholder 5">
            <a:extLst>
              <a:ext uri="{FF2B5EF4-FFF2-40B4-BE49-F238E27FC236}">
                <a16:creationId xmlns:a16="http://schemas.microsoft.com/office/drawing/2014/main" id="{544B428F-C5C7-1B46-8C3C-1DE33A18D760}"/>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D732CD2-3DC1-E844-8BB4-3D58D770C0D9}"/>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231145167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857A4D1-FA2D-3444-9239-8DB7609F691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51AC2039-6EBD-604D-B528-D992730934D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34F2D838-7DAE-C849-8160-5A6C48562A3B}"/>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5B2FE7B6-2B92-9444-842C-7110C587AF7B}"/>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69755C24-5527-FB46-AF32-A562756D3B1D}"/>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A2117AA-2E5A-514E-B8A7-17D3E0A5C5D1}"/>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8" name="Footer Placeholder 7">
            <a:extLst>
              <a:ext uri="{FF2B5EF4-FFF2-40B4-BE49-F238E27FC236}">
                <a16:creationId xmlns:a16="http://schemas.microsoft.com/office/drawing/2014/main" id="{E01F4BDC-902D-0D4B-8491-B59BD3A6C41C}"/>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6F399386-2DC8-3B43-A2D0-E632C787F58B}"/>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5095748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4A57883-42D7-5346-9052-D02167B83C73}"/>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2D8E5E06-AA4C-0249-90E8-DE0A7B50F17A}"/>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4" name="Footer Placeholder 3">
            <a:extLst>
              <a:ext uri="{FF2B5EF4-FFF2-40B4-BE49-F238E27FC236}">
                <a16:creationId xmlns:a16="http://schemas.microsoft.com/office/drawing/2014/main" id="{EA48E5CC-2A58-8A4C-81EE-01C13A8B65C6}"/>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48C49F3-2CFE-0840-A4A9-6BD19C63106B}"/>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125857288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DA6AD11A-451E-3B4B-A9B6-A4BA4629C949}"/>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3" name="Footer Placeholder 2">
            <a:extLst>
              <a:ext uri="{FF2B5EF4-FFF2-40B4-BE49-F238E27FC236}">
                <a16:creationId xmlns:a16="http://schemas.microsoft.com/office/drawing/2014/main" id="{0E61C0C6-C5F5-0C48-A5D5-72D404A5B58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B313956E-6C1D-B442-990F-58C99EF90C63}"/>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274680988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9C516DC-F96D-5E40-A2AE-C975830E0D9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F59EB67B-891A-2B4C-8635-BF2E236A7352}"/>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B54D91A-43FF-9347-9E32-5B1F0AB4D4F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7B57A30-9ECB-824E-A48D-3E1A0BE6376D}"/>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6" name="Footer Placeholder 5">
            <a:extLst>
              <a:ext uri="{FF2B5EF4-FFF2-40B4-BE49-F238E27FC236}">
                <a16:creationId xmlns:a16="http://schemas.microsoft.com/office/drawing/2014/main" id="{08BA47B6-BC29-0E4F-8E89-BB712A1BEAE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FBFF2D8-9F87-8341-8821-5A21E8D5A736}"/>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41389090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1DD47AA-58C3-C649-B11B-1C98FA978890}"/>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0F112BB1-53D9-0D40-8591-D8695342BA0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7F60E32-1FD0-594E-9635-AD9B0F713A7B}"/>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A2370BBB-DC32-2746-A566-37A936FDC7C2}"/>
              </a:ext>
            </a:extLst>
          </p:cNvPr>
          <p:cNvSpPr>
            <a:spLocks noGrp="1"/>
          </p:cNvSpPr>
          <p:nvPr>
            <p:ph type="dt" sz="half" idx="10"/>
          </p:nvPr>
        </p:nvSpPr>
        <p:spPr/>
        <p:txBody>
          <a:bodyPr/>
          <a:lstStyle/>
          <a:p>
            <a:fld id="{47E79DFE-9897-BC4A-839F-E68F62AE268A}" type="datetimeFigureOut">
              <a:rPr lang="en-US" smtClean="0"/>
              <a:t>1/15/2022</a:t>
            </a:fld>
            <a:endParaRPr lang="en-US"/>
          </a:p>
        </p:txBody>
      </p:sp>
      <p:sp>
        <p:nvSpPr>
          <p:cNvPr id="6" name="Footer Placeholder 5">
            <a:extLst>
              <a:ext uri="{FF2B5EF4-FFF2-40B4-BE49-F238E27FC236}">
                <a16:creationId xmlns:a16="http://schemas.microsoft.com/office/drawing/2014/main" id="{2F2DB597-B166-6442-9E5D-C39D8C43C3C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ADC26E21-0EF0-C444-AA2E-6657953886E2}"/>
              </a:ext>
            </a:extLst>
          </p:cNvPr>
          <p:cNvSpPr>
            <a:spLocks noGrp="1"/>
          </p:cNvSpPr>
          <p:nvPr>
            <p:ph type="sldNum" sz="quarter" idx="12"/>
          </p:nvPr>
        </p:nvSpPr>
        <p:spPr/>
        <p:txBody>
          <a:bodyPr/>
          <a:lstStyle/>
          <a:p>
            <a:fld id="{17559CA2-C30B-3041-87DC-E6E1C6FF9740}" type="slidenum">
              <a:rPr lang="en-US" smtClean="0"/>
              <a:t>‹#›</a:t>
            </a:fld>
            <a:endParaRPr lang="en-US"/>
          </a:p>
        </p:txBody>
      </p:sp>
    </p:spTree>
    <p:extLst>
      <p:ext uri="{BB962C8B-B14F-4D97-AF65-F5344CB8AC3E}">
        <p14:creationId xmlns:p14="http://schemas.microsoft.com/office/powerpoint/2010/main" val="245443425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211E8B61-52F9-5649-9DC6-0B088104B66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EFD92454-9CA8-3C41-A3FB-42BBCD22DE2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C5F8C378-BC97-2049-8D7D-D766DA5F8061}"/>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47E79DFE-9897-BC4A-839F-E68F62AE268A}" type="datetimeFigureOut">
              <a:rPr lang="en-US" smtClean="0"/>
              <a:t>1/15/2022</a:t>
            </a:fld>
            <a:endParaRPr lang="en-US"/>
          </a:p>
        </p:txBody>
      </p:sp>
      <p:sp>
        <p:nvSpPr>
          <p:cNvPr id="5" name="Footer Placeholder 4">
            <a:extLst>
              <a:ext uri="{FF2B5EF4-FFF2-40B4-BE49-F238E27FC236}">
                <a16:creationId xmlns:a16="http://schemas.microsoft.com/office/drawing/2014/main" id="{2841779E-AB6F-4540-B71A-01DCB33A2F4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F2DA0CD2-1505-0446-BD0C-4EDC54BC28C1}"/>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7559CA2-C30B-3041-87DC-E6E1C6FF9740}" type="slidenum">
              <a:rPr lang="en-US" smtClean="0"/>
              <a:t>‹#›</a:t>
            </a:fld>
            <a:endParaRPr lang="en-US"/>
          </a:p>
        </p:txBody>
      </p:sp>
    </p:spTree>
    <p:extLst>
      <p:ext uri="{BB962C8B-B14F-4D97-AF65-F5344CB8AC3E}">
        <p14:creationId xmlns:p14="http://schemas.microsoft.com/office/powerpoint/2010/main" val="662895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1BEF8EA8-1A97-8046-80AB-AD19A8ACA1AB}"/>
              </a:ext>
            </a:extLst>
          </p:cNvPr>
          <p:cNvSpPr>
            <a:spLocks noGrp="1"/>
          </p:cNvSpPr>
          <p:nvPr>
            <p:ph type="subTitle" idx="1"/>
          </p:nvPr>
        </p:nvSpPr>
        <p:spPr>
          <a:xfrm>
            <a:off x="1524000" y="4442297"/>
            <a:ext cx="9144000" cy="1655762"/>
          </a:xfrm>
        </p:spPr>
        <p:txBody>
          <a:bodyPr>
            <a:normAutofit fontScale="62500" lnSpcReduction="20000"/>
          </a:bodyPr>
          <a:lstStyle/>
          <a:p>
            <a:pPr algn="l"/>
            <a:r>
              <a:rPr lang="en-US" b="1" dirty="0"/>
              <a:t>Supplementary Figure 1. Attainment, processing, and assessment of effective data processing. </a:t>
            </a:r>
            <a:r>
              <a:rPr lang="en-US" dirty="0"/>
              <a:t>A) Data from GDC for the TCGA-COAD project were obtained and pared down to 78 solid normal tissue and adenocarcinoma pair-matched samples. B) FPKM-normalized data were processed using low count filtration, quantile normalization, and log2 transformation prior to </a:t>
            </a:r>
            <a:r>
              <a:rPr lang="en-US" dirty="0" err="1"/>
              <a:t>SVAseq</a:t>
            </a:r>
            <a:r>
              <a:rPr lang="en-US" dirty="0"/>
              <a:t> batch correction where batch was assigned based on one of three possible TCGA collection sites. Differential expression profiles were then generated using several methods. C) Fully processed expression data for adenocarcinoma vs solid normal tissue was compared using PCA to ensure appropriate clustering based strictly on cancer status (and not site of biopsy) was observed. PC1 (which appeared to be cancer status) accounted for 38.96% of the variance observed in the data following processing.</a:t>
            </a:r>
          </a:p>
          <a:p>
            <a:endParaRPr lang="en-US" dirty="0"/>
          </a:p>
        </p:txBody>
      </p:sp>
      <p:pic>
        <p:nvPicPr>
          <p:cNvPr id="5" name="Picture 4">
            <a:extLst>
              <a:ext uri="{FF2B5EF4-FFF2-40B4-BE49-F238E27FC236}">
                <a16:creationId xmlns:a16="http://schemas.microsoft.com/office/drawing/2014/main" id="{B2F186E5-50C8-834F-A0FA-919CDCA77B87}"/>
              </a:ext>
            </a:extLst>
          </p:cNvPr>
          <p:cNvPicPr>
            <a:picLocks noChangeAspect="1"/>
          </p:cNvPicPr>
          <p:nvPr/>
        </p:nvPicPr>
        <p:blipFill>
          <a:blip r:embed="rId2"/>
          <a:stretch>
            <a:fillRect/>
          </a:stretch>
        </p:blipFill>
        <p:spPr>
          <a:xfrm>
            <a:off x="1524000" y="602315"/>
            <a:ext cx="9452919" cy="3654294"/>
          </a:xfrm>
          <a:prstGeom prst="rect">
            <a:avLst/>
          </a:prstGeom>
        </p:spPr>
      </p:pic>
      <p:sp>
        <p:nvSpPr>
          <p:cNvPr id="6" name="TextBox 5">
            <a:extLst>
              <a:ext uri="{FF2B5EF4-FFF2-40B4-BE49-F238E27FC236}">
                <a16:creationId xmlns:a16="http://schemas.microsoft.com/office/drawing/2014/main" id="{A9943148-DD52-324F-8B4E-5BC06D8A73BF}"/>
              </a:ext>
            </a:extLst>
          </p:cNvPr>
          <p:cNvSpPr txBox="1"/>
          <p:nvPr/>
        </p:nvSpPr>
        <p:spPr>
          <a:xfrm>
            <a:off x="1534511" y="672662"/>
            <a:ext cx="378372" cy="369332"/>
          </a:xfrm>
          <a:prstGeom prst="rect">
            <a:avLst/>
          </a:prstGeom>
          <a:noFill/>
        </p:spPr>
        <p:txBody>
          <a:bodyPr wrap="square" rtlCol="0">
            <a:spAutoFit/>
          </a:bodyPr>
          <a:lstStyle/>
          <a:p>
            <a:r>
              <a:rPr lang="en-US" dirty="0"/>
              <a:t>A</a:t>
            </a:r>
          </a:p>
        </p:txBody>
      </p:sp>
      <p:sp>
        <p:nvSpPr>
          <p:cNvPr id="7" name="TextBox 6">
            <a:extLst>
              <a:ext uri="{FF2B5EF4-FFF2-40B4-BE49-F238E27FC236}">
                <a16:creationId xmlns:a16="http://schemas.microsoft.com/office/drawing/2014/main" id="{0B306A60-16B9-9E44-B092-72CA4F733597}"/>
              </a:ext>
            </a:extLst>
          </p:cNvPr>
          <p:cNvSpPr txBox="1"/>
          <p:nvPr/>
        </p:nvSpPr>
        <p:spPr>
          <a:xfrm>
            <a:off x="1534511" y="1749970"/>
            <a:ext cx="378372" cy="369332"/>
          </a:xfrm>
          <a:prstGeom prst="rect">
            <a:avLst/>
          </a:prstGeom>
          <a:noFill/>
        </p:spPr>
        <p:txBody>
          <a:bodyPr wrap="square" rtlCol="0">
            <a:spAutoFit/>
          </a:bodyPr>
          <a:lstStyle/>
          <a:p>
            <a:r>
              <a:rPr lang="en-US" dirty="0"/>
              <a:t>B</a:t>
            </a:r>
          </a:p>
        </p:txBody>
      </p:sp>
      <p:sp>
        <p:nvSpPr>
          <p:cNvPr id="8" name="TextBox 7">
            <a:extLst>
              <a:ext uri="{FF2B5EF4-FFF2-40B4-BE49-F238E27FC236}">
                <a16:creationId xmlns:a16="http://schemas.microsoft.com/office/drawing/2014/main" id="{E6E701F7-B9A1-BC4D-A9B7-2D600E34E0D5}"/>
              </a:ext>
            </a:extLst>
          </p:cNvPr>
          <p:cNvSpPr txBox="1"/>
          <p:nvPr/>
        </p:nvSpPr>
        <p:spPr>
          <a:xfrm>
            <a:off x="7141781" y="668142"/>
            <a:ext cx="378372" cy="369332"/>
          </a:xfrm>
          <a:prstGeom prst="rect">
            <a:avLst/>
          </a:prstGeom>
          <a:noFill/>
        </p:spPr>
        <p:txBody>
          <a:bodyPr wrap="square" rtlCol="0">
            <a:spAutoFit/>
          </a:bodyPr>
          <a:lstStyle/>
          <a:p>
            <a:r>
              <a:rPr lang="en-US" dirty="0"/>
              <a:t>C</a:t>
            </a:r>
          </a:p>
        </p:txBody>
      </p:sp>
    </p:spTree>
    <p:extLst>
      <p:ext uri="{BB962C8B-B14F-4D97-AF65-F5344CB8AC3E}">
        <p14:creationId xmlns:p14="http://schemas.microsoft.com/office/powerpoint/2010/main" val="137421921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3</TotalTime>
  <Words>146</Words>
  <Application>Microsoft Office PowerPoint</Application>
  <PresentationFormat>Widescreen</PresentationFormat>
  <Paragraphs>4</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lizadeh, Madeline</dc:creator>
  <cp:lastModifiedBy>Raufman, Jean-Pierre</cp:lastModifiedBy>
  <cp:revision>1</cp:revision>
  <dcterms:created xsi:type="dcterms:W3CDTF">2022-01-15T03:33:59Z</dcterms:created>
  <dcterms:modified xsi:type="dcterms:W3CDTF">2022-01-15T15:02:00Z</dcterms:modified>
</cp:coreProperties>
</file>